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3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3696" y="102"/>
      </p:cViewPr>
      <p:guideLst>
        <p:guide orient="horz" pos="32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9206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8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6032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5772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0579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4285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5062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9058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9203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03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0203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0C88DF-F7D0-452E-90B9-FD392733EBB4}" type="datetimeFigureOut">
              <a:rPr lang="it-IT" smtClean="0"/>
              <a:t>23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C4E4E-873E-46D7-B3AF-D2E9BB6C2B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866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38"/>
          <a:stretch/>
        </p:blipFill>
        <p:spPr bwMode="auto">
          <a:xfrm>
            <a:off x="1545455" y="2627784"/>
            <a:ext cx="4081900" cy="26837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4653136" y="299885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= 0.792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2482427" y="2258452"/>
            <a:ext cx="189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it-IT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ponse</a:t>
            </a:r>
            <a:r>
              <a:rPr lang="it-I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to MART-1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2154292" y="4367009"/>
            <a:ext cx="12747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der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476672" y="467544"/>
            <a:ext cx="59766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it-IT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eier plot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relapse-fre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1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solid lin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responding to MART-1 vaccination (n=13) (dotted line). Months are calculated since time of randomization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onders are defined as patients in which at least a two-fold increase of the frequency of MART-1-specific T cells was observed between pre and post-treatment. P value by log-rank test.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Connettore 1 7"/>
          <p:cNvCxnSpPr/>
          <p:nvPr/>
        </p:nvCxnSpPr>
        <p:spPr>
          <a:xfrm>
            <a:off x="1844824" y="4248834"/>
            <a:ext cx="2880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ttangolo 8"/>
          <p:cNvSpPr/>
          <p:nvPr/>
        </p:nvSpPr>
        <p:spPr>
          <a:xfrm>
            <a:off x="2154292" y="4110335"/>
            <a:ext cx="10102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ders</a:t>
            </a:r>
            <a:endParaRPr lang="it-IT" sz="1200" dirty="0"/>
          </a:p>
        </p:txBody>
      </p:sp>
      <p:cxnSp>
        <p:nvCxnSpPr>
          <p:cNvPr id="11" name="Connettore 1 10"/>
          <p:cNvCxnSpPr/>
          <p:nvPr/>
        </p:nvCxnSpPr>
        <p:spPr>
          <a:xfrm>
            <a:off x="1844824" y="4505508"/>
            <a:ext cx="288032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/>
          <p:cNvSpPr txBox="1"/>
          <p:nvPr/>
        </p:nvSpPr>
        <p:spPr>
          <a:xfrm>
            <a:off x="3062554" y="5076056"/>
            <a:ext cx="73289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285131" y="3632806"/>
            <a:ext cx="172835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pse-free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>
            <a:spLocks noChangeAspect="1"/>
          </p:cNvSpPr>
          <p:nvPr/>
        </p:nvSpPr>
        <p:spPr>
          <a:xfrm>
            <a:off x="1257825" y="4265263"/>
            <a:ext cx="32893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/>
          <p:cNvSpPr txBox="1">
            <a:spLocks noChangeAspect="1"/>
          </p:cNvSpPr>
          <p:nvPr/>
        </p:nvSpPr>
        <p:spPr>
          <a:xfrm>
            <a:off x="1341181" y="4662682"/>
            <a:ext cx="242375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/>
          <p:cNvSpPr txBox="1">
            <a:spLocks noChangeAspect="1"/>
          </p:cNvSpPr>
          <p:nvPr/>
        </p:nvSpPr>
        <p:spPr>
          <a:xfrm>
            <a:off x="1257825" y="3865873"/>
            <a:ext cx="32893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>
            <a:spLocks noChangeAspect="1"/>
          </p:cNvSpPr>
          <p:nvPr/>
        </p:nvSpPr>
        <p:spPr>
          <a:xfrm>
            <a:off x="1257825" y="3478910"/>
            <a:ext cx="32893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>
            <a:spLocks noChangeAspect="1"/>
          </p:cNvSpPr>
          <p:nvPr/>
        </p:nvSpPr>
        <p:spPr>
          <a:xfrm>
            <a:off x="1257825" y="3080368"/>
            <a:ext cx="32893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it-IT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8"/>
          <p:cNvSpPr txBox="1">
            <a:spLocks noChangeAspect="1"/>
          </p:cNvSpPr>
          <p:nvPr/>
        </p:nvSpPr>
        <p:spPr>
          <a:xfrm>
            <a:off x="1341181" y="2686420"/>
            <a:ext cx="242374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just"/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1477429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91</Words>
  <Application>Microsoft Office PowerPoint</Application>
  <PresentationFormat>Presentazione su schermo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rbani Francesca</dc:creator>
  <cp:lastModifiedBy>Moschella Federica</cp:lastModifiedBy>
  <cp:revision>19</cp:revision>
  <dcterms:created xsi:type="dcterms:W3CDTF">2018-05-24T10:14:18Z</dcterms:created>
  <dcterms:modified xsi:type="dcterms:W3CDTF">2019-09-23T10:44:00Z</dcterms:modified>
</cp:coreProperties>
</file>